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  <p:sldId id="260" r:id="rId4"/>
    <p:sldId id="261" r:id="rId5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1EB20FC-C015-199B-A801-18E827F005D8}" name="Chiara Bianca Maria Platania" initials="CP" userId="S::chiara.platania@unict.it::e84850ac-acd1-48b4-bc40-30ab0ea234a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245E5DA-D1E1-4D70-97E0-CDE462C921DC}" v="3" dt="2025-03-26T11:40:13.30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859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38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8/10/relationships/authors" Target="authors.xml"/><Relationship Id="rId5" Type="http://schemas.openxmlformats.org/officeDocument/2006/relationships/slide" Target="slides/slide4.xml"/><Relationship Id="rId10" Type="http://schemas.microsoft.com/office/2015/10/relationships/revisionInfo" Target="revisionInfo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9850563-1111-48B2-946F-7D74A608C97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049420B9-ADC5-4C33-AE55-D0462DA677F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BB73FE5-B5F0-4A45-BDF5-669D2F0673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1A5B0-1569-4A20-914C-3F740BDE8ADB}" type="datetimeFigureOut">
              <a:rPr lang="it-IT" smtClean="0"/>
              <a:t>06/11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1970495-0F5B-4992-86A4-291097E858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C172E48-D982-477A-9BCD-B1F0AB7317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65CD8-6980-4199-826B-BABBD4D2A6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4933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79C9812-BFFB-43F3-ACD8-64289887D6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EE19F092-F3CA-49B7-9CC6-22CA764E12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1D2D3CC-28A2-422D-9BCE-D202C57847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1A5B0-1569-4A20-914C-3F740BDE8ADB}" type="datetimeFigureOut">
              <a:rPr lang="it-IT" smtClean="0"/>
              <a:t>06/11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8305680-ADEB-4F81-B405-5B90435AB4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065E846-2475-4086-936D-95282B08D8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65CD8-6980-4199-826B-BABBD4D2A6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206793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6BDE1984-BE4F-461B-8215-0A96FC44F97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178DE28-BF7E-47F0-85E0-3278FA6988E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40E1A2A-5E2F-43EF-8B59-C20EE4B1A0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1A5B0-1569-4A20-914C-3F740BDE8ADB}" type="datetimeFigureOut">
              <a:rPr lang="it-IT" smtClean="0"/>
              <a:t>06/11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26172BC-D7EF-499D-919C-79ABB97DCB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6C57557-DF03-45D1-90CA-4A91704A89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65CD8-6980-4199-826B-BABBD4D2A6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75045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FCE4E56-938B-41CB-9839-C5EE548E19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1E9A929-025F-4F24-BC3D-3ECC6F3954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C67C1E3-6A09-4959-BEA1-B397A612B5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1A5B0-1569-4A20-914C-3F740BDE8ADB}" type="datetimeFigureOut">
              <a:rPr lang="it-IT" smtClean="0"/>
              <a:t>06/11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57D0AFF-62A8-42A2-BEEF-643DBAB562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108BE07-EB8C-453A-82FC-0B33FCD8F5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65CD8-6980-4199-826B-BABBD4D2A6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039049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4853C9F-9D5B-4A28-8B99-C784A618E5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D900619-6B27-4E07-9E34-18B1EB3CE74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710D04A-ABA6-4778-B0C3-4B02C3BF34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1A5B0-1569-4A20-914C-3F740BDE8ADB}" type="datetimeFigureOut">
              <a:rPr lang="it-IT" smtClean="0"/>
              <a:t>06/11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8FB65C6-D6BE-434A-9D3A-C5A85AB45A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D7ED710-FF05-46AE-9FBA-2BBA57397C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65CD8-6980-4199-826B-BABBD4D2A6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105306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7724B9F-E085-450A-9DA5-01AEC40203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22A95D2-0F10-46B3-8A18-16FE45DD3E6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00355B9-2EC9-498F-9F77-873009CCF1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C152E963-0BF8-47B5-BA19-F30F34775E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1A5B0-1569-4A20-914C-3F740BDE8ADB}" type="datetimeFigureOut">
              <a:rPr lang="it-IT" smtClean="0"/>
              <a:t>06/11/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A9F319B5-A5EB-4319-90E1-80A425A20F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0069295-CC44-445A-B6DA-9FA8DDAC2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65CD8-6980-4199-826B-BABBD4D2A6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71663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05E9D18-0BFA-49DE-B30D-0CE4B289C1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D475AF6-AF1D-4593-923B-4EF9FCCAF8C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275B3944-D64D-409D-8854-29CF0F71B1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3A0E5ACE-360D-4B42-B16C-63015B0CF26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AAC1F7BA-4D53-4444-9294-E167FFD181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79A34D1A-3CF3-418D-9006-F26F680A10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1A5B0-1569-4A20-914C-3F740BDE8ADB}" type="datetimeFigureOut">
              <a:rPr lang="it-IT" smtClean="0"/>
              <a:t>06/11/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D14C1D5-491D-4DDA-AF44-F1E2CD1EBD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479E4904-33A4-4259-966F-E1570E8512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65CD8-6980-4199-826B-BABBD4D2A6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8898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319646D-E0C1-49DB-BE77-52829CB3EB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B6E0B33C-598E-462E-980C-4D6B10BBEF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1A5B0-1569-4A20-914C-3F740BDE8ADB}" type="datetimeFigureOut">
              <a:rPr lang="it-IT" smtClean="0"/>
              <a:t>06/11/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1A9B1EAC-2215-4E13-95A3-C4C6B11BDC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18EE3A17-E7B5-4C26-A5B2-731B84C3DD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65CD8-6980-4199-826B-BABBD4D2A6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3144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F1E715BB-F156-44F0-841D-3721642C6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1A5B0-1569-4A20-914C-3F740BDE8ADB}" type="datetimeFigureOut">
              <a:rPr lang="it-IT" smtClean="0"/>
              <a:t>06/11/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BF0D1499-82D6-433A-8568-1E9E1F54F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021EDA5C-BE49-4DAB-8DBF-B037BB96B1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65CD8-6980-4199-826B-BABBD4D2A6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35098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FEE84D4-738F-4C36-8625-D1DD6FF3A2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0972C34-766D-41D5-9D2C-8CB1D3796FD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AD66796-4BEE-46D7-BFE9-D10C0D9EEA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7764EA1-B86A-4333-9DA7-7D26B9F5E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1A5B0-1569-4A20-914C-3F740BDE8ADB}" type="datetimeFigureOut">
              <a:rPr lang="it-IT" smtClean="0"/>
              <a:t>06/11/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4BB31DF-77C4-40A7-A786-6432DDE8DA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5DED29F-F2D4-41D6-8FA4-1D6E839D78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65CD8-6980-4199-826B-BABBD4D2A6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87761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2C4F7C6-5DBF-45C3-9E30-5C5A692BCF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567A4BAC-EA18-4DDF-92C2-225F87AFB6D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7A3561F-BC7C-4304-9C53-0CF4EDE89AB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7D83B7E-66C7-4B98-AFB0-C2A5EAEBCA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A1A5B0-1569-4A20-914C-3F740BDE8ADB}" type="datetimeFigureOut">
              <a:rPr lang="it-IT" smtClean="0"/>
              <a:t>06/11/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0E2FC039-ECAE-49E1-8DBF-DB4422B41F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1CF6F3B-4963-4729-985F-F9484CEEB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565CD8-6980-4199-826B-BABBD4D2A6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98248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F1315664-1017-4E3F-B43C-F479C7F1E1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835C537-935A-4A84-8B8D-9F1A614269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F07AB68-8B8C-4205-8B81-755AD3BE32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A1A5B0-1569-4A20-914C-3F740BDE8ADB}" type="datetimeFigureOut">
              <a:rPr lang="it-IT" smtClean="0"/>
              <a:t>06/11/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61D0BFB-0E2B-4371-8433-795C591B51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FEB25D3-D120-4AAA-8604-FDECF44EB99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565CD8-6980-4199-826B-BABBD4D2A638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586897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tif"/><Relationship Id="rId4" Type="http://schemas.openxmlformats.org/officeDocument/2006/relationships/image" Target="../media/image4.ti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8ECBBF0C-376D-6A69-ED1E-8AD833A713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/>
          </a:p>
        </p:txBody>
      </p:sp>
      <p:sp>
        <p:nvSpPr>
          <p:cNvPr id="5" name="Rectangle 3">
            <a:extLst>
              <a:ext uri="{FF2B5EF4-FFF2-40B4-BE49-F238E27FC236}">
                <a16:creationId xmlns:a16="http://schemas.microsoft.com/office/drawing/2014/main" id="{C60E2E6A-3461-406F-09B9-4B07F99F7A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3690" y="5343904"/>
            <a:ext cx="9144000" cy="11079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US" sz="1100" b="1" dirty="0"/>
              <a:t>Figure 5. Tipranavir and </a:t>
            </a:r>
            <a:r>
              <a:rPr lang="en-US" sz="1100" b="1" dirty="0" err="1"/>
              <a:t>teniposide</a:t>
            </a:r>
            <a:r>
              <a:rPr lang="en-US" sz="1100" b="1" dirty="0"/>
              <a:t> counteracted hypoxia-induced HIF-1</a:t>
            </a:r>
            <a:r>
              <a:rPr lang="it-IT" sz="1100" b="1" dirty="0"/>
              <a:t>α</a:t>
            </a:r>
            <a:r>
              <a:rPr lang="en-US" sz="1100" b="1" dirty="0"/>
              <a:t> expression. </a:t>
            </a:r>
            <a:r>
              <a:rPr lang="en-US" sz="1100" dirty="0"/>
              <a:t>MIO-M1 cells were pre-treated in </a:t>
            </a:r>
            <a:r>
              <a:rPr lang="en-US" sz="1100" dirty="0" err="1"/>
              <a:t>normoxic</a:t>
            </a:r>
            <a:r>
              <a:rPr lang="en-US" sz="1100" dirty="0"/>
              <a:t> condition for 1 h with tipranavir (</a:t>
            </a:r>
            <a:r>
              <a:rPr lang="en-US" sz="1100" dirty="0" err="1"/>
              <a:t>Tipra</a:t>
            </a:r>
            <a:r>
              <a:rPr lang="en-US" sz="1100" dirty="0"/>
              <a:t>; 1 and 10 µM) and </a:t>
            </a:r>
            <a:r>
              <a:rPr lang="en-US" sz="1100" dirty="0" err="1"/>
              <a:t>teniposide</a:t>
            </a:r>
            <a:r>
              <a:rPr lang="en-US" sz="1100" dirty="0"/>
              <a:t> (Teni,1 and 10 µM) and then exposed to hypoxia insult for 7 h. </a:t>
            </a:r>
            <a:r>
              <a:rPr lang="en-US" sz="1100" b="1" dirty="0"/>
              <a:t>(A, B)</a:t>
            </a:r>
            <a:r>
              <a:rPr lang="en-US" sz="1100" dirty="0"/>
              <a:t> Representative immunoblots and densitometric analysis of HIF-1</a:t>
            </a:r>
            <a:r>
              <a:rPr lang="it-IT" sz="1100" dirty="0"/>
              <a:t>α</a:t>
            </a:r>
            <a:r>
              <a:rPr lang="en-US" sz="1100" dirty="0"/>
              <a:t> in lysates of MIO-M1 treated with tipranavir and after exposure to hypoxia. </a:t>
            </a:r>
            <a:r>
              <a:rPr lang="en-US" sz="1100" b="1" dirty="0"/>
              <a:t>(C, D)</a:t>
            </a:r>
            <a:r>
              <a:rPr lang="en-US" sz="1100" dirty="0"/>
              <a:t> Representative immunoblots and densitometric analysis of HIF-1</a:t>
            </a:r>
            <a:r>
              <a:rPr lang="it-IT" sz="1100" dirty="0"/>
              <a:t>α</a:t>
            </a:r>
            <a:r>
              <a:rPr lang="en-US" sz="1100" dirty="0"/>
              <a:t> in lysates of MIO-M1 treated with </a:t>
            </a:r>
            <a:r>
              <a:rPr lang="en-US" sz="1100" dirty="0" err="1"/>
              <a:t>teniposide</a:t>
            </a:r>
            <a:r>
              <a:rPr lang="en-US" sz="1100" dirty="0"/>
              <a:t> and then exposed to hypoxia. Densitometry analysis of each band was carried out with the Image J program, HIF-1</a:t>
            </a:r>
            <a:r>
              <a:rPr lang="it-IT" sz="1100" dirty="0"/>
              <a:t>α</a:t>
            </a:r>
            <a:r>
              <a:rPr lang="en-US" sz="1100" dirty="0"/>
              <a:t> expression has been normalized to </a:t>
            </a:r>
            <a:r>
              <a:rPr lang="it-IT" sz="1100" dirty="0"/>
              <a:t>β</a:t>
            </a:r>
            <a:r>
              <a:rPr lang="en-US" sz="1100" dirty="0"/>
              <a:t>-actin value. Values are reported as mean ± SD (n=4). Data were analyzed by one-way ANOVA and the Tukey </a:t>
            </a:r>
            <a:r>
              <a:rPr lang="en-US" sz="1100" i="1" dirty="0"/>
              <a:t>post hoc</a:t>
            </a:r>
            <a:r>
              <a:rPr lang="en-US" sz="1100" dirty="0"/>
              <a:t> test for multiple comparisons. *p &lt; 0.05 </a:t>
            </a:r>
            <a:r>
              <a:rPr lang="en-US" sz="1100" i="1" dirty="0"/>
              <a:t>vs.</a:t>
            </a:r>
            <a:r>
              <a:rPr lang="en-US" sz="1100" dirty="0"/>
              <a:t> ctrl; †p&lt;0.05 </a:t>
            </a:r>
            <a:r>
              <a:rPr lang="en-US" sz="1100" i="1" dirty="0"/>
              <a:t>vs.</a:t>
            </a:r>
            <a:r>
              <a:rPr lang="en-US" sz="1100" dirty="0"/>
              <a:t> hypoxia; ‡p&lt;0.05 </a:t>
            </a:r>
            <a:r>
              <a:rPr lang="en-US" sz="1100" i="1" dirty="0"/>
              <a:t>vs.</a:t>
            </a:r>
            <a:r>
              <a:rPr lang="en-US" sz="1100" dirty="0"/>
              <a:t> </a:t>
            </a:r>
            <a:r>
              <a:rPr lang="en-US" sz="1100" dirty="0" err="1"/>
              <a:t>Tipra</a:t>
            </a:r>
            <a:r>
              <a:rPr lang="en-US" sz="1100" dirty="0"/>
              <a:t> 1 µM (B) and </a:t>
            </a:r>
            <a:r>
              <a:rPr lang="en-US" sz="1100" i="1" dirty="0"/>
              <a:t>vs.</a:t>
            </a:r>
            <a:r>
              <a:rPr lang="en-US" sz="1100" dirty="0"/>
              <a:t> Teni 1 µM (D).</a:t>
            </a:r>
            <a:endParaRPr lang="it-IT" sz="1100" dirty="0"/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F8CE52E3-653B-E3B0-A760-8326E7AB40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1314" y="178085"/>
            <a:ext cx="5464995" cy="52119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20294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uppo 25">
            <a:extLst>
              <a:ext uri="{FF2B5EF4-FFF2-40B4-BE49-F238E27FC236}">
                <a16:creationId xmlns:a16="http://schemas.microsoft.com/office/drawing/2014/main" id="{E4AFF7F1-3993-41BE-8828-7A2C1B676A74}"/>
              </a:ext>
            </a:extLst>
          </p:cNvPr>
          <p:cNvGrpSpPr/>
          <p:nvPr/>
        </p:nvGrpSpPr>
        <p:grpSpPr>
          <a:xfrm>
            <a:off x="7008571" y="416930"/>
            <a:ext cx="4536325" cy="2692609"/>
            <a:chOff x="6976871" y="931393"/>
            <a:chExt cx="4536325" cy="2692609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960C47FE-EB6C-4A33-B21D-C8432C55497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976871" y="931393"/>
              <a:ext cx="3386797" cy="2692609"/>
            </a:xfrm>
            <a:prstGeom prst="rect">
              <a:avLst/>
            </a:prstGeom>
          </p:spPr>
        </p:pic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A73789C2-D98C-430F-842C-E82B742A04B9}"/>
                </a:ext>
              </a:extLst>
            </p:cNvPr>
            <p:cNvSpPr txBox="1"/>
            <p:nvPr/>
          </p:nvSpPr>
          <p:spPr>
            <a:xfrm>
              <a:off x="10580866" y="1892215"/>
              <a:ext cx="93233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dirty="0">
                  <a:solidFill>
                    <a:srgbClr val="FF0000"/>
                  </a:solidFill>
                </a:rPr>
                <a:t>β</a:t>
              </a:r>
              <a:r>
                <a:rPr lang="it-IT" dirty="0">
                  <a:solidFill>
                    <a:srgbClr val="FF0000"/>
                  </a:solidFill>
                </a:rPr>
                <a:t>-</a:t>
              </a:r>
              <a:r>
                <a:rPr lang="it-IT" dirty="0" err="1">
                  <a:solidFill>
                    <a:srgbClr val="FF0000"/>
                  </a:solidFill>
                </a:rPr>
                <a:t>Actin</a:t>
              </a:r>
              <a:r>
                <a:rPr lang="it-IT" dirty="0"/>
                <a:t> 42kDa</a:t>
              </a:r>
            </a:p>
          </p:txBody>
        </p:sp>
        <p:sp>
          <p:nvSpPr>
            <p:cNvPr id="11" name="Freccia a destra 10">
              <a:extLst>
                <a:ext uri="{FF2B5EF4-FFF2-40B4-BE49-F238E27FC236}">
                  <a16:creationId xmlns:a16="http://schemas.microsoft.com/office/drawing/2014/main" id="{0ACCE2C9-667D-412D-A6C5-8CFEF39C4FC8}"/>
                </a:ext>
              </a:extLst>
            </p:cNvPr>
            <p:cNvSpPr/>
            <p:nvPr/>
          </p:nvSpPr>
          <p:spPr>
            <a:xfrm rot="10800000">
              <a:off x="10025054" y="2172789"/>
              <a:ext cx="555812" cy="98611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12" name="Gruppo 11">
              <a:extLst>
                <a:ext uri="{FF2B5EF4-FFF2-40B4-BE49-F238E27FC236}">
                  <a16:creationId xmlns:a16="http://schemas.microsoft.com/office/drawing/2014/main" id="{D6602E8F-4942-42D2-96A4-6BBD56C27916}"/>
                </a:ext>
              </a:extLst>
            </p:cNvPr>
            <p:cNvGrpSpPr/>
            <p:nvPr/>
          </p:nvGrpSpPr>
          <p:grpSpPr>
            <a:xfrm>
              <a:off x="7961424" y="2319834"/>
              <a:ext cx="1877341" cy="437424"/>
              <a:chOff x="7017345" y="1584919"/>
              <a:chExt cx="1877341" cy="437424"/>
            </a:xfrm>
          </p:grpSpPr>
          <p:sp>
            <p:nvSpPr>
              <p:cNvPr id="13" name="CasellaDiTesto 12">
                <a:extLst>
                  <a:ext uri="{FF2B5EF4-FFF2-40B4-BE49-F238E27FC236}">
                    <a16:creationId xmlns:a16="http://schemas.microsoft.com/office/drawing/2014/main" id="{CD59CB5D-B668-4F9E-BEA1-06908BE5B95A}"/>
                  </a:ext>
                </a:extLst>
              </p:cNvPr>
              <p:cNvSpPr txBox="1"/>
              <p:nvPr/>
            </p:nvSpPr>
            <p:spPr>
              <a:xfrm>
                <a:off x="7017345" y="1714636"/>
                <a:ext cx="403412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50" dirty="0" err="1"/>
                  <a:t>ctrl</a:t>
                </a:r>
                <a:endParaRPr lang="it-IT" sz="1050" dirty="0"/>
              </a:p>
            </p:txBody>
          </p:sp>
          <p:sp>
            <p:nvSpPr>
              <p:cNvPr id="14" name="CasellaDiTesto 13">
                <a:extLst>
                  <a:ext uri="{FF2B5EF4-FFF2-40B4-BE49-F238E27FC236}">
                    <a16:creationId xmlns:a16="http://schemas.microsoft.com/office/drawing/2014/main" id="{9A4B0BDB-1B7D-4652-9876-59F521D4721A}"/>
                  </a:ext>
                </a:extLst>
              </p:cNvPr>
              <p:cNvSpPr txBox="1"/>
              <p:nvPr/>
            </p:nvSpPr>
            <p:spPr>
              <a:xfrm>
                <a:off x="7459527" y="1591507"/>
                <a:ext cx="403412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50" dirty="0" err="1"/>
                  <a:t>Ctrl</a:t>
                </a:r>
                <a:endParaRPr lang="it-IT" sz="1050" dirty="0"/>
              </a:p>
              <a:p>
                <a:r>
                  <a:rPr lang="it-IT" sz="1050" dirty="0" err="1"/>
                  <a:t>hyp</a:t>
                </a:r>
                <a:endParaRPr lang="it-IT" sz="1050" dirty="0"/>
              </a:p>
            </p:txBody>
          </p:sp>
          <p:sp>
            <p:nvSpPr>
              <p:cNvPr id="15" name="CasellaDiTesto 14">
                <a:extLst>
                  <a:ext uri="{FF2B5EF4-FFF2-40B4-BE49-F238E27FC236}">
                    <a16:creationId xmlns:a16="http://schemas.microsoft.com/office/drawing/2014/main" id="{BFF8DC67-3389-477E-A7A9-91F5D2EC02BD}"/>
                  </a:ext>
                </a:extLst>
              </p:cNvPr>
              <p:cNvSpPr txBox="1"/>
              <p:nvPr/>
            </p:nvSpPr>
            <p:spPr>
              <a:xfrm>
                <a:off x="7892004" y="1584919"/>
                <a:ext cx="502909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50" dirty="0" err="1"/>
                  <a:t>tipra</a:t>
                </a:r>
                <a:r>
                  <a:rPr lang="it-IT" sz="1050" dirty="0"/>
                  <a:t> 1uM</a:t>
                </a:r>
              </a:p>
            </p:txBody>
          </p:sp>
          <p:sp>
            <p:nvSpPr>
              <p:cNvPr id="16" name="CasellaDiTesto 15">
                <a:extLst>
                  <a:ext uri="{FF2B5EF4-FFF2-40B4-BE49-F238E27FC236}">
                    <a16:creationId xmlns:a16="http://schemas.microsoft.com/office/drawing/2014/main" id="{7906501F-7E5D-43CC-95FE-F367A7E2C731}"/>
                  </a:ext>
                </a:extLst>
              </p:cNvPr>
              <p:cNvSpPr txBox="1"/>
              <p:nvPr/>
            </p:nvSpPr>
            <p:spPr>
              <a:xfrm>
                <a:off x="8359883" y="1606845"/>
                <a:ext cx="534803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50" dirty="0" err="1"/>
                  <a:t>tipra</a:t>
                </a:r>
                <a:r>
                  <a:rPr lang="it-IT" sz="1050" dirty="0"/>
                  <a:t> 10uM</a:t>
                </a:r>
              </a:p>
            </p:txBody>
          </p:sp>
        </p:grpSp>
      </p:grpSp>
      <p:grpSp>
        <p:nvGrpSpPr>
          <p:cNvPr id="25" name="Gruppo 24">
            <a:extLst>
              <a:ext uri="{FF2B5EF4-FFF2-40B4-BE49-F238E27FC236}">
                <a16:creationId xmlns:a16="http://schemas.microsoft.com/office/drawing/2014/main" id="{F3E01A6B-7E59-412A-B219-A4C0D0CAFB5E}"/>
              </a:ext>
            </a:extLst>
          </p:cNvPr>
          <p:cNvGrpSpPr/>
          <p:nvPr/>
        </p:nvGrpSpPr>
        <p:grpSpPr>
          <a:xfrm>
            <a:off x="186334" y="591289"/>
            <a:ext cx="4480423" cy="2461213"/>
            <a:chOff x="758332" y="2271400"/>
            <a:chExt cx="4480423" cy="2461213"/>
          </a:xfrm>
        </p:grpSpPr>
        <p:pic>
          <p:nvPicPr>
            <p:cNvPr id="9" name="Immagine 8">
              <a:extLst>
                <a:ext uri="{FF2B5EF4-FFF2-40B4-BE49-F238E27FC236}">
                  <a16:creationId xmlns:a16="http://schemas.microsoft.com/office/drawing/2014/main" id="{69D92EAD-7FF1-4EBC-A938-5652C3695E2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20246" y="2271400"/>
              <a:ext cx="3218509" cy="2461213"/>
            </a:xfrm>
            <a:prstGeom prst="rect">
              <a:avLst/>
            </a:prstGeom>
          </p:spPr>
        </p:pic>
        <p:grpSp>
          <p:nvGrpSpPr>
            <p:cNvPr id="17" name="Gruppo 16">
              <a:extLst>
                <a:ext uri="{FF2B5EF4-FFF2-40B4-BE49-F238E27FC236}">
                  <a16:creationId xmlns:a16="http://schemas.microsoft.com/office/drawing/2014/main" id="{A59D5E77-ABE3-4896-A7A7-AB642CBB23BC}"/>
                </a:ext>
              </a:extLst>
            </p:cNvPr>
            <p:cNvGrpSpPr/>
            <p:nvPr/>
          </p:nvGrpSpPr>
          <p:grpSpPr>
            <a:xfrm>
              <a:off x="2867188" y="3381179"/>
              <a:ext cx="2004015" cy="437424"/>
              <a:chOff x="7017345" y="1584919"/>
              <a:chExt cx="1877341" cy="437424"/>
            </a:xfrm>
          </p:grpSpPr>
          <p:sp>
            <p:nvSpPr>
              <p:cNvPr id="18" name="CasellaDiTesto 17">
                <a:extLst>
                  <a:ext uri="{FF2B5EF4-FFF2-40B4-BE49-F238E27FC236}">
                    <a16:creationId xmlns:a16="http://schemas.microsoft.com/office/drawing/2014/main" id="{5B72E873-C064-44A9-8E61-B6C5A6187BBD}"/>
                  </a:ext>
                </a:extLst>
              </p:cNvPr>
              <p:cNvSpPr txBox="1"/>
              <p:nvPr/>
            </p:nvSpPr>
            <p:spPr>
              <a:xfrm>
                <a:off x="7017345" y="1714636"/>
                <a:ext cx="403412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50" dirty="0" err="1"/>
                  <a:t>ctrl</a:t>
                </a:r>
                <a:endParaRPr lang="it-IT" sz="1050" dirty="0"/>
              </a:p>
            </p:txBody>
          </p:sp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id="{AC43E814-F3C2-4BD8-A8FB-F417F9FDF9BE}"/>
                  </a:ext>
                </a:extLst>
              </p:cNvPr>
              <p:cNvSpPr txBox="1"/>
              <p:nvPr/>
            </p:nvSpPr>
            <p:spPr>
              <a:xfrm>
                <a:off x="7459527" y="1591507"/>
                <a:ext cx="403412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50" dirty="0" err="1"/>
                  <a:t>Ctrl</a:t>
                </a:r>
                <a:endParaRPr lang="it-IT" sz="1050" dirty="0"/>
              </a:p>
              <a:p>
                <a:r>
                  <a:rPr lang="it-IT" sz="1050" dirty="0" err="1"/>
                  <a:t>hyp</a:t>
                </a:r>
                <a:endParaRPr lang="it-IT" sz="1050" dirty="0"/>
              </a:p>
            </p:txBody>
          </p:sp>
          <p:sp>
            <p:nvSpPr>
              <p:cNvPr id="20" name="CasellaDiTesto 19">
                <a:extLst>
                  <a:ext uri="{FF2B5EF4-FFF2-40B4-BE49-F238E27FC236}">
                    <a16:creationId xmlns:a16="http://schemas.microsoft.com/office/drawing/2014/main" id="{722735B3-3152-4563-A099-3FE736C82184}"/>
                  </a:ext>
                </a:extLst>
              </p:cNvPr>
              <p:cNvSpPr txBox="1"/>
              <p:nvPr/>
            </p:nvSpPr>
            <p:spPr>
              <a:xfrm>
                <a:off x="7892004" y="1584919"/>
                <a:ext cx="502909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50" dirty="0" err="1"/>
                  <a:t>tipra</a:t>
                </a:r>
                <a:r>
                  <a:rPr lang="it-IT" sz="1050" dirty="0"/>
                  <a:t> 1uM</a:t>
                </a:r>
              </a:p>
            </p:txBody>
          </p:sp>
          <p:sp>
            <p:nvSpPr>
              <p:cNvPr id="21" name="CasellaDiTesto 20">
                <a:extLst>
                  <a:ext uri="{FF2B5EF4-FFF2-40B4-BE49-F238E27FC236}">
                    <a16:creationId xmlns:a16="http://schemas.microsoft.com/office/drawing/2014/main" id="{626BBCF6-2BD5-4F9E-A7F1-4EF1F8C01915}"/>
                  </a:ext>
                </a:extLst>
              </p:cNvPr>
              <p:cNvSpPr txBox="1"/>
              <p:nvPr/>
            </p:nvSpPr>
            <p:spPr>
              <a:xfrm>
                <a:off x="8359883" y="1606845"/>
                <a:ext cx="534803" cy="4154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50" dirty="0" err="1"/>
                  <a:t>tipra</a:t>
                </a:r>
                <a:r>
                  <a:rPr lang="it-IT" sz="1050" dirty="0"/>
                  <a:t> 10uM</a:t>
                </a:r>
              </a:p>
            </p:txBody>
          </p:sp>
        </p:grp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A0AC6787-6E26-413A-8D7C-ACE96171C2D3}"/>
                </a:ext>
              </a:extLst>
            </p:cNvPr>
            <p:cNvSpPr txBox="1"/>
            <p:nvPr/>
          </p:nvSpPr>
          <p:spPr>
            <a:xfrm>
              <a:off x="758332" y="3595516"/>
              <a:ext cx="9201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solidFill>
                    <a:srgbClr val="FF0000"/>
                  </a:solidFill>
                </a:rPr>
                <a:t>HIF-1</a:t>
              </a:r>
              <a:r>
                <a:rPr lang="el-GR" dirty="0">
                  <a:solidFill>
                    <a:srgbClr val="FF0000"/>
                  </a:solidFill>
                </a:rPr>
                <a:t>α</a:t>
              </a:r>
              <a:endParaRPr lang="it-IT" dirty="0">
                <a:solidFill>
                  <a:srgbClr val="FF0000"/>
                </a:solidFill>
              </a:endParaRP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7437008E-1B1D-465A-BEFF-D28B1693DEE4}"/>
                </a:ext>
              </a:extLst>
            </p:cNvPr>
            <p:cNvSpPr txBox="1"/>
            <p:nvPr/>
          </p:nvSpPr>
          <p:spPr>
            <a:xfrm>
              <a:off x="778121" y="3931244"/>
              <a:ext cx="88583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100kDa</a:t>
              </a:r>
            </a:p>
          </p:txBody>
        </p:sp>
        <p:sp>
          <p:nvSpPr>
            <p:cNvPr id="24" name="Freccia a destra 23">
              <a:extLst>
                <a:ext uri="{FF2B5EF4-FFF2-40B4-BE49-F238E27FC236}">
                  <a16:creationId xmlns:a16="http://schemas.microsoft.com/office/drawing/2014/main" id="{3D4EDD56-54CA-46C3-9DF1-E0F383D67E4F}"/>
                </a:ext>
              </a:extLst>
            </p:cNvPr>
            <p:cNvSpPr/>
            <p:nvPr/>
          </p:nvSpPr>
          <p:spPr>
            <a:xfrm>
              <a:off x="1742340" y="3998924"/>
              <a:ext cx="555812" cy="233971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</p:grp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6EE7007D-A946-471D-9719-E85C7A72E435}"/>
              </a:ext>
            </a:extLst>
          </p:cNvPr>
          <p:cNvSpPr txBox="1"/>
          <p:nvPr/>
        </p:nvSpPr>
        <p:spPr>
          <a:xfrm>
            <a:off x="4401671" y="116541"/>
            <a:ext cx="268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solidFill>
                  <a:srgbClr val="FF0000"/>
                </a:solidFill>
              </a:rPr>
              <a:t>TIPRANAVIR</a:t>
            </a:r>
          </a:p>
        </p:txBody>
      </p:sp>
      <p:grpSp>
        <p:nvGrpSpPr>
          <p:cNvPr id="3" name="Gruppo 2">
            <a:extLst>
              <a:ext uri="{FF2B5EF4-FFF2-40B4-BE49-F238E27FC236}">
                <a16:creationId xmlns:a16="http://schemas.microsoft.com/office/drawing/2014/main" id="{FC20A994-0211-BA6A-1995-00472BFE799D}"/>
              </a:ext>
            </a:extLst>
          </p:cNvPr>
          <p:cNvGrpSpPr/>
          <p:nvPr/>
        </p:nvGrpSpPr>
        <p:grpSpPr>
          <a:xfrm>
            <a:off x="558082" y="4344286"/>
            <a:ext cx="10986814" cy="2271924"/>
            <a:chOff x="509340" y="786586"/>
            <a:chExt cx="10986814" cy="2271924"/>
          </a:xfrm>
        </p:grpSpPr>
        <p:grpSp>
          <p:nvGrpSpPr>
            <p:cNvPr id="4" name="Gruppo 3">
              <a:extLst>
                <a:ext uri="{FF2B5EF4-FFF2-40B4-BE49-F238E27FC236}">
                  <a16:creationId xmlns:a16="http://schemas.microsoft.com/office/drawing/2014/main" id="{96BB28B3-11EC-0A8B-B431-13A1738E3F6E}"/>
                </a:ext>
              </a:extLst>
            </p:cNvPr>
            <p:cNvGrpSpPr/>
            <p:nvPr/>
          </p:nvGrpSpPr>
          <p:grpSpPr>
            <a:xfrm>
              <a:off x="509340" y="1016650"/>
              <a:ext cx="4293926" cy="1630390"/>
              <a:chOff x="-276234" y="403961"/>
              <a:chExt cx="4293926" cy="1630390"/>
            </a:xfrm>
          </p:grpSpPr>
          <p:grpSp>
            <p:nvGrpSpPr>
              <p:cNvPr id="36" name="Gruppo 35">
                <a:extLst>
                  <a:ext uri="{FF2B5EF4-FFF2-40B4-BE49-F238E27FC236}">
                    <a16:creationId xmlns:a16="http://schemas.microsoft.com/office/drawing/2014/main" id="{A6C64B91-4A10-4622-47AA-03250E3E5914}"/>
                  </a:ext>
                </a:extLst>
              </p:cNvPr>
              <p:cNvGrpSpPr/>
              <p:nvPr/>
            </p:nvGrpSpPr>
            <p:grpSpPr>
              <a:xfrm>
                <a:off x="-276234" y="403961"/>
                <a:ext cx="4293926" cy="1630390"/>
                <a:chOff x="5362566" y="1757631"/>
                <a:chExt cx="4293926" cy="1630390"/>
              </a:xfrm>
            </p:grpSpPr>
            <p:pic>
              <p:nvPicPr>
                <p:cNvPr id="42" name="Immagine 41">
                  <a:extLst>
                    <a:ext uri="{FF2B5EF4-FFF2-40B4-BE49-F238E27FC236}">
                      <a16:creationId xmlns:a16="http://schemas.microsoft.com/office/drawing/2014/main" id="{08B2BED1-9983-8CA2-8F98-41355B5116F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9419" t="15788" r="4657" b="24999"/>
                <a:stretch/>
              </p:blipFill>
              <p:spPr>
                <a:xfrm>
                  <a:off x="6696635" y="1757631"/>
                  <a:ext cx="2959857" cy="1630390"/>
                </a:xfrm>
                <a:prstGeom prst="rect">
                  <a:avLst/>
                </a:prstGeom>
              </p:spPr>
            </p:pic>
            <p:sp>
              <p:nvSpPr>
                <p:cNvPr id="43" name="CasellaDiTesto 42">
                  <a:extLst>
                    <a:ext uri="{FF2B5EF4-FFF2-40B4-BE49-F238E27FC236}">
                      <a16:creationId xmlns:a16="http://schemas.microsoft.com/office/drawing/2014/main" id="{B8EB5667-CE4F-305F-7B58-989BCA633727}"/>
                    </a:ext>
                  </a:extLst>
                </p:cNvPr>
                <p:cNvSpPr txBox="1"/>
                <p:nvPr/>
              </p:nvSpPr>
              <p:spPr>
                <a:xfrm>
                  <a:off x="5362566" y="2958119"/>
                  <a:ext cx="885834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dirty="0"/>
                    <a:t>100kDa</a:t>
                  </a:r>
                </a:p>
              </p:txBody>
            </p:sp>
            <p:sp>
              <p:nvSpPr>
                <p:cNvPr id="44" name="Freccia a destra 43">
                  <a:extLst>
                    <a:ext uri="{FF2B5EF4-FFF2-40B4-BE49-F238E27FC236}">
                      <a16:creationId xmlns:a16="http://schemas.microsoft.com/office/drawing/2014/main" id="{2966814F-AF3D-22EE-B0AD-C1C0D65A3C13}"/>
                    </a:ext>
                  </a:extLst>
                </p:cNvPr>
                <p:cNvSpPr/>
                <p:nvPr/>
              </p:nvSpPr>
              <p:spPr>
                <a:xfrm>
                  <a:off x="6326785" y="3025799"/>
                  <a:ext cx="555812" cy="233971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grpSp>
            <p:nvGrpSpPr>
              <p:cNvPr id="37" name="Gruppo 36">
                <a:extLst>
                  <a:ext uri="{FF2B5EF4-FFF2-40B4-BE49-F238E27FC236}">
                    <a16:creationId xmlns:a16="http://schemas.microsoft.com/office/drawing/2014/main" id="{9A85133B-9827-CDEF-404F-36370F33508C}"/>
                  </a:ext>
                </a:extLst>
              </p:cNvPr>
              <p:cNvGrpSpPr/>
              <p:nvPr/>
            </p:nvGrpSpPr>
            <p:grpSpPr>
              <a:xfrm>
                <a:off x="1732006" y="1295311"/>
                <a:ext cx="2104888" cy="437424"/>
                <a:chOff x="7017345" y="1584919"/>
                <a:chExt cx="1877341" cy="437424"/>
              </a:xfrm>
            </p:grpSpPr>
            <p:sp>
              <p:nvSpPr>
                <p:cNvPr id="38" name="CasellaDiTesto 37">
                  <a:extLst>
                    <a:ext uri="{FF2B5EF4-FFF2-40B4-BE49-F238E27FC236}">
                      <a16:creationId xmlns:a16="http://schemas.microsoft.com/office/drawing/2014/main" id="{3AFF129E-62F0-0C0E-BEAD-9C12B4E971C7}"/>
                    </a:ext>
                  </a:extLst>
                </p:cNvPr>
                <p:cNvSpPr txBox="1"/>
                <p:nvPr/>
              </p:nvSpPr>
              <p:spPr>
                <a:xfrm>
                  <a:off x="7017345" y="1714636"/>
                  <a:ext cx="403412" cy="25391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050" dirty="0" err="1"/>
                    <a:t>ctrl</a:t>
                  </a:r>
                  <a:endParaRPr lang="it-IT" sz="1050" dirty="0"/>
                </a:p>
              </p:txBody>
            </p:sp>
            <p:sp>
              <p:nvSpPr>
                <p:cNvPr id="39" name="CasellaDiTesto 38">
                  <a:extLst>
                    <a:ext uri="{FF2B5EF4-FFF2-40B4-BE49-F238E27FC236}">
                      <a16:creationId xmlns:a16="http://schemas.microsoft.com/office/drawing/2014/main" id="{86C96815-E8FC-4DEF-5C58-9898B8518DCA}"/>
                    </a:ext>
                  </a:extLst>
                </p:cNvPr>
                <p:cNvSpPr txBox="1"/>
                <p:nvPr/>
              </p:nvSpPr>
              <p:spPr>
                <a:xfrm>
                  <a:off x="7459527" y="1591507"/>
                  <a:ext cx="403412" cy="4154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050" dirty="0" err="1"/>
                    <a:t>Ctrl</a:t>
                  </a:r>
                  <a:endParaRPr lang="it-IT" sz="1050" dirty="0"/>
                </a:p>
                <a:p>
                  <a:r>
                    <a:rPr lang="it-IT" sz="1050" dirty="0" err="1"/>
                    <a:t>hyp</a:t>
                  </a:r>
                  <a:endParaRPr lang="it-IT" sz="1050" dirty="0"/>
                </a:p>
              </p:txBody>
            </p:sp>
            <p:sp>
              <p:nvSpPr>
                <p:cNvPr id="40" name="CasellaDiTesto 39">
                  <a:extLst>
                    <a:ext uri="{FF2B5EF4-FFF2-40B4-BE49-F238E27FC236}">
                      <a16:creationId xmlns:a16="http://schemas.microsoft.com/office/drawing/2014/main" id="{F88BABE8-9D61-284C-3E11-73EBBA3209B9}"/>
                    </a:ext>
                  </a:extLst>
                </p:cNvPr>
                <p:cNvSpPr txBox="1"/>
                <p:nvPr/>
              </p:nvSpPr>
              <p:spPr>
                <a:xfrm>
                  <a:off x="7892004" y="1584919"/>
                  <a:ext cx="502909" cy="4154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050" dirty="0" err="1"/>
                    <a:t>Teni</a:t>
                  </a:r>
                  <a:r>
                    <a:rPr lang="it-IT" sz="1050" dirty="0"/>
                    <a:t> 1uM</a:t>
                  </a:r>
                </a:p>
              </p:txBody>
            </p:sp>
            <p:sp>
              <p:nvSpPr>
                <p:cNvPr id="41" name="CasellaDiTesto 40">
                  <a:extLst>
                    <a:ext uri="{FF2B5EF4-FFF2-40B4-BE49-F238E27FC236}">
                      <a16:creationId xmlns:a16="http://schemas.microsoft.com/office/drawing/2014/main" id="{D10DD06F-D122-8321-F6D3-E6EA82D44B9A}"/>
                    </a:ext>
                  </a:extLst>
                </p:cNvPr>
                <p:cNvSpPr txBox="1"/>
                <p:nvPr/>
              </p:nvSpPr>
              <p:spPr>
                <a:xfrm>
                  <a:off x="8359883" y="1606845"/>
                  <a:ext cx="534803" cy="41549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it-IT" sz="1050" dirty="0" err="1"/>
                    <a:t>Teni</a:t>
                  </a:r>
                  <a:r>
                    <a:rPr lang="it-IT" sz="1050" dirty="0"/>
                    <a:t> 10uM</a:t>
                  </a:r>
                </a:p>
              </p:txBody>
            </p:sp>
          </p:grpSp>
        </p:grpSp>
        <p:pic>
          <p:nvPicPr>
            <p:cNvPr id="6" name="Immagine 5">
              <a:extLst>
                <a:ext uri="{FF2B5EF4-FFF2-40B4-BE49-F238E27FC236}">
                  <a16:creationId xmlns:a16="http://schemas.microsoft.com/office/drawing/2014/main" id="{DA6C2AFB-0E5D-4C85-0BE3-46614E582AB2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53914" y="786586"/>
              <a:ext cx="2846534" cy="2271924"/>
            </a:xfrm>
            <a:prstGeom prst="rect">
              <a:avLst/>
            </a:prstGeom>
          </p:spPr>
        </p:pic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1668D822-99C5-A739-60D8-6957FD92DD85}"/>
                </a:ext>
              </a:extLst>
            </p:cNvPr>
            <p:cNvSpPr txBox="1"/>
            <p:nvPr/>
          </p:nvSpPr>
          <p:spPr>
            <a:xfrm>
              <a:off x="10563824" y="1016650"/>
              <a:ext cx="93233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dirty="0">
                  <a:solidFill>
                    <a:srgbClr val="FF0000"/>
                  </a:solidFill>
                </a:rPr>
                <a:t>β</a:t>
              </a:r>
              <a:r>
                <a:rPr lang="it-IT" dirty="0">
                  <a:solidFill>
                    <a:srgbClr val="FF0000"/>
                  </a:solidFill>
                </a:rPr>
                <a:t>-</a:t>
              </a:r>
              <a:r>
                <a:rPr lang="it-IT" dirty="0" err="1">
                  <a:solidFill>
                    <a:srgbClr val="FF0000"/>
                  </a:solidFill>
                </a:rPr>
                <a:t>Actin</a:t>
              </a:r>
              <a:endParaRPr lang="it-IT" dirty="0">
                <a:solidFill>
                  <a:srgbClr val="FF0000"/>
                </a:solidFill>
              </a:endParaRPr>
            </a:p>
            <a:p>
              <a:r>
                <a:rPr lang="it-IT" dirty="0"/>
                <a:t> 42kDa</a:t>
              </a:r>
            </a:p>
          </p:txBody>
        </p:sp>
        <p:sp>
          <p:nvSpPr>
            <p:cNvPr id="8" name="Freccia a destra 7">
              <a:extLst>
                <a:ext uri="{FF2B5EF4-FFF2-40B4-BE49-F238E27FC236}">
                  <a16:creationId xmlns:a16="http://schemas.microsoft.com/office/drawing/2014/main" id="{8BB01019-6E58-2BBE-50F7-9F74626A098B}"/>
                </a:ext>
              </a:extLst>
            </p:cNvPr>
            <p:cNvSpPr/>
            <p:nvPr/>
          </p:nvSpPr>
          <p:spPr>
            <a:xfrm rot="10800000">
              <a:off x="10030293" y="1339816"/>
              <a:ext cx="555812" cy="98611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C42DAD86-FC21-AAA7-57BC-AF3E395ADEF4}"/>
                </a:ext>
              </a:extLst>
            </p:cNvPr>
            <p:cNvSpPr txBox="1"/>
            <p:nvPr/>
          </p:nvSpPr>
          <p:spPr>
            <a:xfrm>
              <a:off x="509340" y="1857125"/>
              <a:ext cx="92015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dirty="0">
                  <a:solidFill>
                    <a:srgbClr val="FF0000"/>
                  </a:solidFill>
                </a:rPr>
                <a:t>HIF-1</a:t>
              </a:r>
              <a:r>
                <a:rPr lang="el-GR" dirty="0">
                  <a:solidFill>
                    <a:srgbClr val="FF0000"/>
                  </a:solidFill>
                </a:rPr>
                <a:t>α</a:t>
              </a:r>
              <a:endParaRPr lang="it-IT" dirty="0">
                <a:solidFill>
                  <a:srgbClr val="FF0000"/>
                </a:solidFill>
              </a:endParaRPr>
            </a:p>
          </p:txBody>
        </p: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id="{33836213-A9D2-199D-6951-426DD9D3D4B8}"/>
                </a:ext>
              </a:extLst>
            </p:cNvPr>
            <p:cNvSpPr txBox="1"/>
            <p:nvPr/>
          </p:nvSpPr>
          <p:spPr>
            <a:xfrm>
              <a:off x="8461284" y="1501544"/>
              <a:ext cx="45230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 err="1"/>
                <a:t>ctrl</a:t>
              </a:r>
              <a:endParaRPr lang="it-IT" sz="1050" dirty="0"/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5C0937CA-FD83-021C-5D3A-7263A7BD9353}"/>
                </a:ext>
              </a:extLst>
            </p:cNvPr>
            <p:cNvSpPr txBox="1"/>
            <p:nvPr/>
          </p:nvSpPr>
          <p:spPr>
            <a:xfrm>
              <a:off x="8877877" y="1416397"/>
              <a:ext cx="452308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 err="1"/>
                <a:t>Ctrl</a:t>
              </a:r>
              <a:endParaRPr lang="it-IT" sz="1050" dirty="0"/>
            </a:p>
            <a:p>
              <a:r>
                <a:rPr lang="it-IT" sz="1050" dirty="0" err="1"/>
                <a:t>hyp</a:t>
              </a:r>
              <a:endParaRPr lang="it-IT" sz="1050" dirty="0"/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242C4B8A-1C6D-F3E3-0741-A6951966274F}"/>
                </a:ext>
              </a:extLst>
            </p:cNvPr>
            <p:cNvSpPr txBox="1"/>
            <p:nvPr/>
          </p:nvSpPr>
          <p:spPr>
            <a:xfrm>
              <a:off x="9239854" y="1416397"/>
              <a:ext cx="563865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 err="1"/>
                <a:t>Teni</a:t>
              </a:r>
              <a:r>
                <a:rPr lang="it-IT" sz="1050" dirty="0"/>
                <a:t> 1uM</a:t>
              </a:r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8E049B0F-A0DD-A0B4-0D09-D67684556A29}"/>
                </a:ext>
              </a:extLst>
            </p:cNvPr>
            <p:cNvSpPr txBox="1"/>
            <p:nvPr/>
          </p:nvSpPr>
          <p:spPr>
            <a:xfrm>
              <a:off x="9656447" y="1438427"/>
              <a:ext cx="599625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50" dirty="0" err="1"/>
                <a:t>Teni</a:t>
              </a:r>
              <a:r>
                <a:rPr lang="it-IT" sz="1050" dirty="0"/>
                <a:t> 10uM</a:t>
              </a:r>
            </a:p>
          </p:txBody>
        </p:sp>
      </p:grpSp>
      <p:sp>
        <p:nvSpPr>
          <p:cNvPr id="45" name="CasellaDiTesto 44">
            <a:extLst>
              <a:ext uri="{FF2B5EF4-FFF2-40B4-BE49-F238E27FC236}">
                <a16:creationId xmlns:a16="http://schemas.microsoft.com/office/drawing/2014/main" id="{295CAC7B-0B95-DCDD-19F2-F2CF800066ED}"/>
              </a:ext>
            </a:extLst>
          </p:cNvPr>
          <p:cNvSpPr txBox="1"/>
          <p:nvPr/>
        </p:nvSpPr>
        <p:spPr>
          <a:xfrm>
            <a:off x="4504375" y="3890789"/>
            <a:ext cx="2689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b="1" dirty="0">
                <a:solidFill>
                  <a:srgbClr val="FF0000"/>
                </a:solidFill>
              </a:rPr>
              <a:t>TENIPOSIDE</a:t>
            </a:r>
          </a:p>
        </p:txBody>
      </p:sp>
    </p:spTree>
    <p:extLst>
      <p:ext uri="{BB962C8B-B14F-4D97-AF65-F5344CB8AC3E}">
        <p14:creationId xmlns:p14="http://schemas.microsoft.com/office/powerpoint/2010/main" val="12869107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6FD2DD4D-FF9C-1238-FC5D-EF2181F4A61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32669" y="5224333"/>
            <a:ext cx="7820025" cy="11079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algn="just"/>
            <a:r>
              <a:rPr lang="en-US" sz="1100" b="1" dirty="0"/>
              <a:t>Figure 7. Tipranavir and </a:t>
            </a:r>
            <a:r>
              <a:rPr lang="en-US" sz="1100" b="1" dirty="0" err="1"/>
              <a:t>teniposide</a:t>
            </a:r>
            <a:r>
              <a:rPr lang="en-US" sz="1100" b="1" dirty="0"/>
              <a:t> protected HUVECs against PMA-induced VEGF-A release</a:t>
            </a:r>
            <a:endParaRPr lang="it-IT" sz="1100" dirty="0"/>
          </a:p>
          <a:p>
            <a:pPr algn="just"/>
            <a:r>
              <a:rPr lang="en-US" sz="1100" dirty="0"/>
              <a:t>HUVECs were treated for 48 hours with phorbol 12-myristate 13-acetate (PMA; 100nM) alone or in the presence of tipranavir (</a:t>
            </a:r>
            <a:r>
              <a:rPr lang="en-US" sz="1100" dirty="0" err="1"/>
              <a:t>Tipra</a:t>
            </a:r>
            <a:r>
              <a:rPr lang="en-US" sz="1100" dirty="0"/>
              <a:t>; A, B) or </a:t>
            </a:r>
            <a:r>
              <a:rPr lang="en-US" sz="1100" dirty="0" err="1"/>
              <a:t>teniposide</a:t>
            </a:r>
            <a:r>
              <a:rPr lang="en-US" sz="1100" dirty="0"/>
              <a:t> (Teni; C, D) at 1µM or 10 µM. Control cells were treated for 48 h with the solvent (dimethyl sulfoxide; Ctrl). Densitometry analysis of each band was carried out with the Image J program; VEGF expression has been normalized to α-Tubulin value. Values are reported as mean ± SD (n=4). Data were analyzed by one-way ANOVA and the Tukey </a:t>
            </a:r>
            <a:r>
              <a:rPr lang="en-US" sz="1100" i="1" dirty="0"/>
              <a:t>post hoc</a:t>
            </a:r>
            <a:r>
              <a:rPr lang="en-US" sz="1100" dirty="0"/>
              <a:t> test for multiple comparisons. *p &lt; 0.05 </a:t>
            </a:r>
            <a:r>
              <a:rPr lang="en-US" sz="1100" i="1" dirty="0"/>
              <a:t>vs.</a:t>
            </a:r>
            <a:r>
              <a:rPr lang="en-US" sz="1100" dirty="0"/>
              <a:t> ctrl; †p&lt;0.05 </a:t>
            </a:r>
            <a:r>
              <a:rPr lang="en-US" sz="1100" i="1" dirty="0"/>
              <a:t>vs.</a:t>
            </a:r>
            <a:r>
              <a:rPr lang="en-US" sz="1100" dirty="0"/>
              <a:t> PMA.</a:t>
            </a:r>
            <a:endParaRPr lang="it-IT" sz="1100" dirty="0"/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C07B171A-75C0-9F5A-5B41-60ADF65A1C4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5904" y="439220"/>
            <a:ext cx="6394806" cy="4650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86929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Immagine che contiene testo, statico, libro, carta&#10;&#10;Descrizione generata automaticamente">
            <a:extLst>
              <a:ext uri="{FF2B5EF4-FFF2-40B4-BE49-F238E27FC236}">
                <a16:creationId xmlns:a16="http://schemas.microsoft.com/office/drawing/2014/main" id="{13B9085C-5E53-CB2A-3C72-0B765B9B343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28" t="38131" r="54583" b="10141"/>
          <a:stretch/>
        </p:blipFill>
        <p:spPr>
          <a:xfrm rot="5400000">
            <a:off x="1756295" y="4218882"/>
            <a:ext cx="1924049" cy="2378056"/>
          </a:xfrm>
          <a:prstGeom prst="rect">
            <a:avLst/>
          </a:prstGeom>
        </p:spPr>
      </p:pic>
      <p:pic>
        <p:nvPicPr>
          <p:cNvPr id="5" name="Immagine 4" descr="Immagine che contiene testo, schermata, Rettangolo&#10;&#10;Descrizione generata automaticamente">
            <a:extLst>
              <a:ext uri="{FF2B5EF4-FFF2-40B4-BE49-F238E27FC236}">
                <a16:creationId xmlns:a16="http://schemas.microsoft.com/office/drawing/2014/main" id="{16A0CDE2-F37A-F010-3F3D-02864A5F267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06" t="36913" r="51805" b="16852"/>
          <a:stretch/>
        </p:blipFill>
        <p:spPr>
          <a:xfrm rot="5400000">
            <a:off x="1641993" y="1061010"/>
            <a:ext cx="2152653" cy="2378056"/>
          </a:xfrm>
          <a:prstGeom prst="rect">
            <a:avLst/>
          </a:prstGeom>
        </p:spPr>
      </p:pic>
      <p:sp>
        <p:nvSpPr>
          <p:cNvPr id="6" name="CasellaDiTesto 5">
            <a:extLst>
              <a:ext uri="{FF2B5EF4-FFF2-40B4-BE49-F238E27FC236}">
                <a16:creationId xmlns:a16="http://schemas.microsoft.com/office/drawing/2014/main" id="{BB14E48D-6492-A67C-03A0-8438685EC454}"/>
              </a:ext>
            </a:extLst>
          </p:cNvPr>
          <p:cNvSpPr txBox="1"/>
          <p:nvPr/>
        </p:nvSpPr>
        <p:spPr>
          <a:xfrm>
            <a:off x="3907348" y="1404688"/>
            <a:ext cx="1247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VEGF</a:t>
            </a:r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EFC6FB9F-912F-E6CD-B6E4-4A3B2DCF7F0F}"/>
              </a:ext>
            </a:extLst>
          </p:cNvPr>
          <p:cNvSpPr txBox="1"/>
          <p:nvPr/>
        </p:nvSpPr>
        <p:spPr>
          <a:xfrm>
            <a:off x="3849560" y="4631424"/>
            <a:ext cx="1247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/>
              <a:t>α</a:t>
            </a:r>
            <a:r>
              <a:rPr lang="it-IT" dirty="0"/>
              <a:t>-</a:t>
            </a:r>
            <a:r>
              <a:rPr lang="it-IT" dirty="0" err="1"/>
              <a:t>Tubulin</a:t>
            </a:r>
            <a:endParaRPr lang="it-IT" dirty="0"/>
          </a:p>
        </p:txBody>
      </p:sp>
      <p:grpSp>
        <p:nvGrpSpPr>
          <p:cNvPr id="8" name="Gruppo 7">
            <a:extLst>
              <a:ext uri="{FF2B5EF4-FFF2-40B4-BE49-F238E27FC236}">
                <a16:creationId xmlns:a16="http://schemas.microsoft.com/office/drawing/2014/main" id="{946AA2AC-BDAB-F31F-A271-7DA0FAF18CFB}"/>
              </a:ext>
            </a:extLst>
          </p:cNvPr>
          <p:cNvGrpSpPr/>
          <p:nvPr/>
        </p:nvGrpSpPr>
        <p:grpSpPr>
          <a:xfrm>
            <a:off x="2296022" y="492431"/>
            <a:ext cx="2645148" cy="392304"/>
            <a:chOff x="2236362" y="1097411"/>
            <a:chExt cx="2645148" cy="359413"/>
          </a:xfrm>
        </p:grpSpPr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D30564FF-D78E-8F7C-985D-366DE0274F45}"/>
                </a:ext>
              </a:extLst>
            </p:cNvPr>
            <p:cNvSpPr txBox="1"/>
            <p:nvPr/>
          </p:nvSpPr>
          <p:spPr>
            <a:xfrm rot="18925587">
              <a:off x="2236362" y="1231246"/>
              <a:ext cx="1059932" cy="2255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TR + DMSO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C5D451AC-4C29-D7B2-2781-639D34D95C9C}"/>
                </a:ext>
              </a:extLst>
            </p:cNvPr>
            <p:cNvSpPr txBox="1"/>
            <p:nvPr/>
          </p:nvSpPr>
          <p:spPr>
            <a:xfrm rot="18925587">
              <a:off x="2622241" y="1187882"/>
              <a:ext cx="1142362" cy="2255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MA 100 </a:t>
              </a:r>
              <a:r>
                <a:rPr lang="it-I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F114F851-ECEF-E73B-C87E-0685A8325F95}"/>
                </a:ext>
              </a:extLst>
            </p:cNvPr>
            <p:cNvSpPr txBox="1"/>
            <p:nvPr/>
          </p:nvSpPr>
          <p:spPr>
            <a:xfrm rot="18925587">
              <a:off x="3008217" y="1118907"/>
              <a:ext cx="1407405" cy="2255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IPRA 1 </a:t>
              </a:r>
              <a:r>
                <a:rPr lang="it-I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+ PMA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1CF83B48-FF03-1700-3FD0-11841C31FA70}"/>
                </a:ext>
              </a:extLst>
            </p:cNvPr>
            <p:cNvSpPr txBox="1"/>
            <p:nvPr/>
          </p:nvSpPr>
          <p:spPr>
            <a:xfrm rot="18925587">
              <a:off x="3408556" y="1097411"/>
              <a:ext cx="1472954" cy="2255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IPRA 10 </a:t>
              </a:r>
              <a:r>
                <a:rPr lang="it-I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+ PMA</a:t>
              </a:r>
            </a:p>
          </p:txBody>
        </p:sp>
      </p:grpSp>
      <p:sp>
        <p:nvSpPr>
          <p:cNvPr id="13" name="CasellaDiTesto 14">
            <a:extLst>
              <a:ext uri="{FF2B5EF4-FFF2-40B4-BE49-F238E27FC236}">
                <a16:creationId xmlns:a16="http://schemas.microsoft.com/office/drawing/2014/main" id="{625E0C5C-BBE9-CC85-9F16-8EE03D221A87}"/>
              </a:ext>
            </a:extLst>
          </p:cNvPr>
          <p:cNvSpPr txBox="1"/>
          <p:nvPr/>
        </p:nvSpPr>
        <p:spPr>
          <a:xfrm rot="18925587">
            <a:off x="1832099" y="646123"/>
            <a:ext cx="10599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CTR + DMSO</a:t>
            </a:r>
          </a:p>
        </p:txBody>
      </p:sp>
      <p:pic>
        <p:nvPicPr>
          <p:cNvPr id="14" name="Immagine 13" descr="Immagine che contiene Rettangolo, testo, muro, arte&#10;&#10;Descrizione generata automaticamente">
            <a:extLst>
              <a:ext uri="{FF2B5EF4-FFF2-40B4-BE49-F238E27FC236}">
                <a16:creationId xmlns:a16="http://schemas.microsoft.com/office/drawing/2014/main" id="{46581F62-7349-3732-D1CE-8CD862F4BB2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81" t="44102" r="33369" b="45996"/>
          <a:stretch/>
        </p:blipFill>
        <p:spPr>
          <a:xfrm>
            <a:off x="5852432" y="4378877"/>
            <a:ext cx="2175782" cy="314325"/>
          </a:xfrm>
          <a:prstGeom prst="rect">
            <a:avLst/>
          </a:prstGeom>
        </p:spPr>
      </p:pic>
      <p:pic>
        <p:nvPicPr>
          <p:cNvPr id="15" name="Immagine 14" descr="Immagine che contiene testo, Rettangolo, schermata, calligrafia&#10;&#10;Descrizione generata automaticamente">
            <a:extLst>
              <a:ext uri="{FF2B5EF4-FFF2-40B4-BE49-F238E27FC236}">
                <a16:creationId xmlns:a16="http://schemas.microsoft.com/office/drawing/2014/main" id="{F525F9E1-7913-9F8B-D332-0F72CEB7E00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70" t="25257" r="19101" b="23956"/>
          <a:stretch/>
        </p:blipFill>
        <p:spPr>
          <a:xfrm>
            <a:off x="5852433" y="2569127"/>
            <a:ext cx="2219474" cy="1514475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54EF8F94-3EDE-05CE-DF39-5188C77D1899}"/>
              </a:ext>
            </a:extLst>
          </p:cNvPr>
          <p:cNvSpPr txBox="1"/>
          <p:nvPr/>
        </p:nvSpPr>
        <p:spPr>
          <a:xfrm>
            <a:off x="8137066" y="2816777"/>
            <a:ext cx="1247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VEGF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6B79BEED-1966-F9A5-12FF-31CDACF29ECE}"/>
              </a:ext>
            </a:extLst>
          </p:cNvPr>
          <p:cNvSpPr txBox="1"/>
          <p:nvPr/>
        </p:nvSpPr>
        <p:spPr>
          <a:xfrm>
            <a:off x="8109713" y="4323870"/>
            <a:ext cx="12477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/>
              <a:t>α</a:t>
            </a:r>
            <a:r>
              <a:rPr lang="it-IT" dirty="0"/>
              <a:t>-</a:t>
            </a:r>
            <a:r>
              <a:rPr lang="it-IT" dirty="0" err="1"/>
              <a:t>Tubulin</a:t>
            </a:r>
            <a:endParaRPr lang="it-IT" dirty="0"/>
          </a:p>
        </p:txBody>
      </p:sp>
      <p:grpSp>
        <p:nvGrpSpPr>
          <p:cNvPr id="18" name="Gruppo 17">
            <a:extLst>
              <a:ext uri="{FF2B5EF4-FFF2-40B4-BE49-F238E27FC236}">
                <a16:creationId xmlns:a16="http://schemas.microsoft.com/office/drawing/2014/main" id="{2F8E2E9E-64CF-EDF3-4746-676FAA2220F8}"/>
              </a:ext>
            </a:extLst>
          </p:cNvPr>
          <p:cNvGrpSpPr/>
          <p:nvPr/>
        </p:nvGrpSpPr>
        <p:grpSpPr>
          <a:xfrm>
            <a:off x="6762144" y="1999723"/>
            <a:ext cx="2180017" cy="329137"/>
            <a:chOff x="2256743" y="1161294"/>
            <a:chExt cx="2180017" cy="301541"/>
          </a:xfrm>
        </p:grpSpPr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7C4036C8-6436-B86C-5402-0F6740FD9213}"/>
                </a:ext>
              </a:extLst>
            </p:cNvPr>
            <p:cNvSpPr txBox="1"/>
            <p:nvPr/>
          </p:nvSpPr>
          <p:spPr>
            <a:xfrm rot="18925587">
              <a:off x="2256743" y="1237258"/>
              <a:ext cx="1041236" cy="2255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TR + DMSO</a:t>
              </a:r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578FBEA4-A16F-C73E-6829-F81FD5556000}"/>
                </a:ext>
              </a:extLst>
            </p:cNvPr>
            <p:cNvSpPr txBox="1"/>
            <p:nvPr/>
          </p:nvSpPr>
          <p:spPr>
            <a:xfrm rot="18925587">
              <a:off x="2544683" y="1187882"/>
              <a:ext cx="1142362" cy="2255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MA 100 </a:t>
              </a:r>
              <a:r>
                <a:rPr lang="it-I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7344C2D2-14CE-5271-9634-B38D51393E3C}"/>
                </a:ext>
              </a:extLst>
            </p:cNvPr>
            <p:cNvSpPr txBox="1"/>
            <p:nvPr/>
          </p:nvSpPr>
          <p:spPr>
            <a:xfrm rot="18925587">
              <a:off x="2804617" y="1165776"/>
              <a:ext cx="1287655" cy="2255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ENI 1 </a:t>
              </a:r>
              <a:r>
                <a:rPr lang="it-I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+ PMA</a:t>
              </a: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FD3C89BC-F2F9-450E-9CC7-65AA88910D15}"/>
                </a:ext>
              </a:extLst>
            </p:cNvPr>
            <p:cNvSpPr txBox="1"/>
            <p:nvPr/>
          </p:nvSpPr>
          <p:spPr>
            <a:xfrm rot="18925587">
              <a:off x="3137029" y="1161294"/>
              <a:ext cx="1299731" cy="2255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TENI 10 </a:t>
              </a:r>
              <a:r>
                <a:rPr lang="it-I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+ PMA</a:t>
              </a:r>
            </a:p>
          </p:txBody>
        </p:sp>
      </p:grpSp>
      <p:sp>
        <p:nvSpPr>
          <p:cNvPr id="23" name="CasellaDiTesto 6">
            <a:extLst>
              <a:ext uri="{FF2B5EF4-FFF2-40B4-BE49-F238E27FC236}">
                <a16:creationId xmlns:a16="http://schemas.microsoft.com/office/drawing/2014/main" id="{CC2711CC-993A-98B1-F6E9-970C8D5296B3}"/>
              </a:ext>
            </a:extLst>
          </p:cNvPr>
          <p:cNvSpPr txBox="1"/>
          <p:nvPr/>
        </p:nvSpPr>
        <p:spPr>
          <a:xfrm rot="18925587">
            <a:off x="6159731" y="2055594"/>
            <a:ext cx="10412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CTR + DMSO</a:t>
            </a:r>
          </a:p>
        </p:txBody>
      </p:sp>
      <p:sp>
        <p:nvSpPr>
          <p:cNvPr id="24" name="CasellaDiTesto 7">
            <a:extLst>
              <a:ext uri="{FF2B5EF4-FFF2-40B4-BE49-F238E27FC236}">
                <a16:creationId xmlns:a16="http://schemas.microsoft.com/office/drawing/2014/main" id="{A260F338-E7EC-F71E-4BC9-D315FB5309CA}"/>
              </a:ext>
            </a:extLst>
          </p:cNvPr>
          <p:cNvSpPr txBox="1"/>
          <p:nvPr/>
        </p:nvSpPr>
        <p:spPr>
          <a:xfrm rot="18925587">
            <a:off x="6447671" y="2001699"/>
            <a:ext cx="1142362" cy="2462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PMA 100 </a:t>
            </a:r>
            <a:r>
              <a:rPr lang="it-IT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endParaRPr lang="it-IT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034292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23</Words>
  <Application>Microsoft Macintosh PowerPoint</Application>
  <PresentationFormat>Widescreen</PresentationFormat>
  <Paragraphs>47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a Lazzara</dc:creator>
  <cp:lastModifiedBy>Francesca Lazzara</cp:lastModifiedBy>
  <cp:revision>47</cp:revision>
  <dcterms:created xsi:type="dcterms:W3CDTF">2023-05-10T10:12:10Z</dcterms:created>
  <dcterms:modified xsi:type="dcterms:W3CDTF">2025-11-06T14:10:21Z</dcterms:modified>
</cp:coreProperties>
</file>